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304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106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903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299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462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5545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288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321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0467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1232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4686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199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310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AEDC7A0-63BE-4F09-810A-CBC83406BEBC}"/>
              </a:ext>
            </a:extLst>
          </p:cNvPr>
          <p:cNvSpPr txBox="1"/>
          <p:nvPr/>
        </p:nvSpPr>
        <p:spPr>
          <a:xfrm>
            <a:off x="0" y="3912898"/>
            <a:ext cx="6858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sFigure3.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ultivariate cox hazard proportional analysis for overall survival of the CRC patients.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e performed multivariate Cox regression analysis to compute a HR according to age ≥ 70, male sex, depth of invasion (pT4), the presence of LN metastasis, GPS 1-2, low hemoglobin, NLR (≥ 5), PLR (≥150) and low transferrin. Backward stepwise elimination (likelihood method) with a threshold of P = 0.20 was used to select variables for the final model.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C111F550-2ECA-4238-94E7-FE5286C855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39128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4865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91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澤山 浩</dc:creator>
  <cp:lastModifiedBy>澤山 浩</cp:lastModifiedBy>
  <cp:revision>9</cp:revision>
  <dcterms:created xsi:type="dcterms:W3CDTF">2020-05-05T12:02:23Z</dcterms:created>
  <dcterms:modified xsi:type="dcterms:W3CDTF">2020-09-27T10:42:03Z</dcterms:modified>
</cp:coreProperties>
</file>